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E75B6"/>
    <a:srgbClr val="C55A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12" autoAdjust="0"/>
  </p:normalViewPr>
  <p:slideViewPr>
    <p:cSldViewPr snapToGrid="0">
      <p:cViewPr varScale="1">
        <p:scale>
          <a:sx n="84" d="100"/>
          <a:sy n="84" d="100"/>
        </p:scale>
        <p:origin x="29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349B97-BC09-4CE3-AA84-590F93ABD331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CDD036-10FA-49C4-888B-8FAF4FA3F5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729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191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866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547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79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631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46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212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336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195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1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147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8E3A2-0EFB-427C-B69A-228DC067951C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78A94-111A-46AF-9E59-F42CEA2ECB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2725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CF21B8F4-12BF-42EC-9F37-9CEB678B5DF1}"/>
              </a:ext>
            </a:extLst>
          </p:cNvPr>
          <p:cNvSpPr txBox="1"/>
          <p:nvPr/>
        </p:nvSpPr>
        <p:spPr>
          <a:xfrm>
            <a:off x="977910" y="1340769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7C9BEB51-B4BB-43D6-9044-838241289274}"/>
              </a:ext>
            </a:extLst>
          </p:cNvPr>
          <p:cNvGrpSpPr/>
          <p:nvPr/>
        </p:nvGrpSpPr>
        <p:grpSpPr>
          <a:xfrm>
            <a:off x="1765311" y="1936940"/>
            <a:ext cx="3619489" cy="5017182"/>
            <a:chOff x="1294501" y="1949640"/>
            <a:chExt cx="4081542" cy="5657660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F08F2025-9CA3-4337-B546-2D43606A1C34}"/>
                </a:ext>
              </a:extLst>
            </p:cNvPr>
            <p:cNvSpPr/>
            <p:nvPr/>
          </p:nvSpPr>
          <p:spPr>
            <a:xfrm>
              <a:off x="1389655" y="2242167"/>
              <a:ext cx="164416" cy="2393300"/>
            </a:xfrm>
            <a:prstGeom prst="rect">
              <a:avLst/>
            </a:prstGeom>
            <a:solidFill>
              <a:srgbClr val="FCA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3200"/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BE29A42B-9AA4-4D6C-9B49-713605A67857}"/>
                </a:ext>
              </a:extLst>
            </p:cNvPr>
            <p:cNvSpPr/>
            <p:nvPr/>
          </p:nvSpPr>
          <p:spPr>
            <a:xfrm>
              <a:off x="1389655" y="4682196"/>
              <a:ext cx="164416" cy="2393300"/>
            </a:xfrm>
            <a:prstGeom prst="rect">
              <a:avLst/>
            </a:prstGeom>
            <a:solidFill>
              <a:srgbClr val="55A0FB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320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181B96E-7B24-4804-B0DB-9EAF256CAA44}"/>
                </a:ext>
              </a:extLst>
            </p:cNvPr>
            <p:cNvSpPr txBox="1"/>
            <p:nvPr/>
          </p:nvSpPr>
          <p:spPr>
            <a:xfrm rot="5400000">
              <a:off x="836480" y="3612913"/>
              <a:ext cx="1248423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GCT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D3D8109-A2CC-4992-8018-776CF627DC21}"/>
                </a:ext>
              </a:extLst>
            </p:cNvPr>
            <p:cNvSpPr txBox="1"/>
            <p:nvPr/>
          </p:nvSpPr>
          <p:spPr>
            <a:xfrm rot="5400000">
              <a:off x="817792" y="6037016"/>
              <a:ext cx="1248423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NAT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55A7956B-39A4-4F7C-B54B-8400FF8D27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16" b="12105"/>
            <a:stretch/>
          </p:blipFill>
          <p:spPr>
            <a:xfrm>
              <a:off x="2140450" y="1949640"/>
              <a:ext cx="3235593" cy="5179137"/>
            </a:xfrm>
            <a:prstGeom prst="rect">
              <a:avLst/>
            </a:prstGeom>
          </p:spPr>
        </p:pic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ED8AC659-9147-49EE-9934-E5FFA90AD531}"/>
                </a:ext>
              </a:extLst>
            </p:cNvPr>
            <p:cNvGrpSpPr/>
            <p:nvPr/>
          </p:nvGrpSpPr>
          <p:grpSpPr>
            <a:xfrm>
              <a:off x="1406162" y="2195407"/>
              <a:ext cx="824232" cy="2514207"/>
              <a:chOff x="3450151" y="2725186"/>
              <a:chExt cx="539318" cy="1645111"/>
            </a:xfrm>
          </p:grpSpPr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42D4C9F2-D829-4C50-BCB5-B9C259C7F484}"/>
                  </a:ext>
                </a:extLst>
              </p:cNvPr>
              <p:cNvSpPr txBox="1"/>
              <p:nvPr/>
            </p:nvSpPr>
            <p:spPr>
              <a:xfrm>
                <a:off x="3450151" y="2725186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GCT-1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20EB7CC6-2E60-4C22-97ED-DB27875CB647}"/>
                  </a:ext>
                </a:extLst>
              </p:cNvPr>
              <p:cNvSpPr txBox="1"/>
              <p:nvPr/>
            </p:nvSpPr>
            <p:spPr>
              <a:xfrm>
                <a:off x="3450151" y="284583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2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243A6471-DCF5-4CED-BA96-EDF0459EA4DE}"/>
                  </a:ext>
                </a:extLst>
              </p:cNvPr>
              <p:cNvSpPr txBox="1"/>
              <p:nvPr/>
            </p:nvSpPr>
            <p:spPr>
              <a:xfrm>
                <a:off x="3450151" y="2968748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3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F0038B16-23ED-4E69-BFAD-16C1E9B4A935}"/>
                  </a:ext>
                </a:extLst>
              </p:cNvPr>
              <p:cNvSpPr txBox="1"/>
              <p:nvPr/>
            </p:nvSpPr>
            <p:spPr>
              <a:xfrm>
                <a:off x="3450151" y="3083416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4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62F94FE0-83C1-4C99-9EEA-0A5A50B44B6B}"/>
                  </a:ext>
                </a:extLst>
              </p:cNvPr>
              <p:cNvSpPr txBox="1"/>
              <p:nvPr/>
            </p:nvSpPr>
            <p:spPr>
              <a:xfrm>
                <a:off x="3450151" y="3206333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5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3EAEC721-9262-4EFC-B945-71164EAC08E5}"/>
                  </a:ext>
                </a:extLst>
              </p:cNvPr>
              <p:cNvSpPr txBox="1"/>
              <p:nvPr/>
            </p:nvSpPr>
            <p:spPr>
              <a:xfrm>
                <a:off x="3450151" y="333026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GCT-6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4ED82AE9-4196-418C-AEBD-6196C8BC5A78}"/>
                  </a:ext>
                </a:extLst>
              </p:cNvPr>
              <p:cNvSpPr txBox="1"/>
              <p:nvPr/>
            </p:nvSpPr>
            <p:spPr>
              <a:xfrm>
                <a:off x="3450151" y="345318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7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4533A777-E52F-4267-B5F8-5A4B57EC107A}"/>
                  </a:ext>
                </a:extLst>
              </p:cNvPr>
              <p:cNvSpPr txBox="1"/>
              <p:nvPr/>
            </p:nvSpPr>
            <p:spPr>
              <a:xfrm>
                <a:off x="3450151" y="3572218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8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FE62438C-DCE3-48EF-B469-88EF48233C39}"/>
                  </a:ext>
                </a:extLst>
              </p:cNvPr>
              <p:cNvSpPr txBox="1"/>
              <p:nvPr/>
            </p:nvSpPr>
            <p:spPr>
              <a:xfrm>
                <a:off x="3450151" y="3695465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9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BADCAD55-7A8D-461B-8190-8AD288D7098E}"/>
                  </a:ext>
                </a:extLst>
              </p:cNvPr>
              <p:cNvSpPr txBox="1"/>
              <p:nvPr/>
            </p:nvSpPr>
            <p:spPr>
              <a:xfrm>
                <a:off x="3450151" y="3812447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10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B5840837-7D58-4AB6-8586-DC2C4CAC2A1C}"/>
                  </a:ext>
                </a:extLst>
              </p:cNvPr>
              <p:cNvSpPr txBox="1"/>
              <p:nvPr/>
            </p:nvSpPr>
            <p:spPr>
              <a:xfrm>
                <a:off x="3450151" y="3937171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11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71B26712-C059-4101-8E7F-664A963E24BE}"/>
                  </a:ext>
                </a:extLst>
              </p:cNvPr>
              <p:cNvSpPr txBox="1"/>
              <p:nvPr/>
            </p:nvSpPr>
            <p:spPr>
              <a:xfrm>
                <a:off x="3450151" y="405733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12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5D25EAB3-8E68-4E59-8CBB-C5CDDBFF67A9}"/>
                  </a:ext>
                </a:extLst>
              </p:cNvPr>
              <p:cNvSpPr txBox="1"/>
              <p:nvPr/>
            </p:nvSpPr>
            <p:spPr>
              <a:xfrm>
                <a:off x="3450151" y="4177267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>
                    <a:latin typeface="Arial" panose="020B0604020202020204" pitchFamily="34" charset="0"/>
                    <a:cs typeface="Arial" panose="020B0604020202020204" pitchFamily="34" charset="0"/>
                  </a:rPr>
                  <a:t>GCT-13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338C66CE-40EB-4B6A-AE03-B5FEBAED84E1}"/>
                </a:ext>
              </a:extLst>
            </p:cNvPr>
            <p:cNvGrpSpPr/>
            <p:nvPr/>
          </p:nvGrpSpPr>
          <p:grpSpPr>
            <a:xfrm>
              <a:off x="1405445" y="4603847"/>
              <a:ext cx="824232" cy="2514207"/>
              <a:chOff x="3450151" y="2725186"/>
              <a:chExt cx="539318" cy="1645111"/>
            </a:xfrm>
          </p:grpSpPr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A24BCD9D-4516-4AEE-A942-B822005A81BA}"/>
                  </a:ext>
                </a:extLst>
              </p:cNvPr>
              <p:cNvSpPr txBox="1"/>
              <p:nvPr/>
            </p:nvSpPr>
            <p:spPr>
              <a:xfrm>
                <a:off x="3450151" y="2725186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1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DD0142E0-C2EF-4D85-B82F-63EBB2F50EBE}"/>
                  </a:ext>
                </a:extLst>
              </p:cNvPr>
              <p:cNvSpPr txBox="1"/>
              <p:nvPr/>
            </p:nvSpPr>
            <p:spPr>
              <a:xfrm>
                <a:off x="3450151" y="284583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2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052A2AC2-5A9E-4AB6-AD35-CAB0FCB25E41}"/>
                  </a:ext>
                </a:extLst>
              </p:cNvPr>
              <p:cNvSpPr txBox="1"/>
              <p:nvPr/>
            </p:nvSpPr>
            <p:spPr>
              <a:xfrm>
                <a:off x="3450151" y="2968748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3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B0EB695E-6C59-420C-B10B-DBC14BEE89E8}"/>
                  </a:ext>
                </a:extLst>
              </p:cNvPr>
              <p:cNvSpPr txBox="1"/>
              <p:nvPr/>
            </p:nvSpPr>
            <p:spPr>
              <a:xfrm>
                <a:off x="3450151" y="3083416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4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65F333C8-2766-43A7-8607-2ED3B253C224}"/>
                  </a:ext>
                </a:extLst>
              </p:cNvPr>
              <p:cNvSpPr txBox="1"/>
              <p:nvPr/>
            </p:nvSpPr>
            <p:spPr>
              <a:xfrm>
                <a:off x="3450151" y="3206333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5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BCA0EF1B-A7E4-4EA2-AD6A-A2E26313EEDB}"/>
                  </a:ext>
                </a:extLst>
              </p:cNvPr>
              <p:cNvSpPr txBox="1"/>
              <p:nvPr/>
            </p:nvSpPr>
            <p:spPr>
              <a:xfrm>
                <a:off x="3450151" y="333026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6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BFD9F1D-6828-4A97-AD0B-8C716A0DDFA2}"/>
                  </a:ext>
                </a:extLst>
              </p:cNvPr>
              <p:cNvSpPr txBox="1"/>
              <p:nvPr/>
            </p:nvSpPr>
            <p:spPr>
              <a:xfrm>
                <a:off x="3450151" y="345318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7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1E69F62D-3165-4B15-A337-CBF4135050CF}"/>
                  </a:ext>
                </a:extLst>
              </p:cNvPr>
              <p:cNvSpPr txBox="1"/>
              <p:nvPr/>
            </p:nvSpPr>
            <p:spPr>
              <a:xfrm>
                <a:off x="3450151" y="3572218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8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1327807A-4E75-4C34-A2B2-C15207D201B0}"/>
                  </a:ext>
                </a:extLst>
              </p:cNvPr>
              <p:cNvSpPr txBox="1"/>
              <p:nvPr/>
            </p:nvSpPr>
            <p:spPr>
              <a:xfrm>
                <a:off x="3450151" y="3695465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9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8419CE8F-AFDD-4EA6-B051-4D6009ED2CCE}"/>
                  </a:ext>
                </a:extLst>
              </p:cNvPr>
              <p:cNvSpPr txBox="1"/>
              <p:nvPr/>
            </p:nvSpPr>
            <p:spPr>
              <a:xfrm>
                <a:off x="3450151" y="3812447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10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5A49601A-0B0A-49D1-B6F4-358EB93F44A2}"/>
                  </a:ext>
                </a:extLst>
              </p:cNvPr>
              <p:cNvSpPr txBox="1"/>
              <p:nvPr/>
            </p:nvSpPr>
            <p:spPr>
              <a:xfrm>
                <a:off x="3450151" y="3937171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11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72C90617-8132-4953-84D1-F4613919A20E}"/>
                  </a:ext>
                </a:extLst>
              </p:cNvPr>
              <p:cNvSpPr txBox="1"/>
              <p:nvPr/>
            </p:nvSpPr>
            <p:spPr>
              <a:xfrm>
                <a:off x="3450151" y="4057332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12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D748F03B-7529-4ED0-94D4-7C715959102A}"/>
                  </a:ext>
                </a:extLst>
              </p:cNvPr>
              <p:cNvSpPr txBox="1"/>
              <p:nvPr/>
            </p:nvSpPr>
            <p:spPr>
              <a:xfrm>
                <a:off x="3450151" y="4177267"/>
                <a:ext cx="539318" cy="19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T-13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AAEF7FE-FE9E-4588-A1F4-3389430ECBA6}"/>
                </a:ext>
              </a:extLst>
            </p:cNvPr>
            <p:cNvSpPr txBox="1"/>
            <p:nvPr/>
          </p:nvSpPr>
          <p:spPr>
            <a:xfrm rot="18855138">
              <a:off x="2187659" y="7159646"/>
              <a:ext cx="600301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02BA8EE-36E4-4B19-8825-EC1B5541969B}"/>
                </a:ext>
              </a:extLst>
            </p:cNvPr>
            <p:cNvSpPr txBox="1"/>
            <p:nvPr/>
          </p:nvSpPr>
          <p:spPr>
            <a:xfrm rot="18855138">
              <a:off x="1830594" y="7159646"/>
              <a:ext cx="600301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4BF90E3-53FA-4712-94FB-9F7A133BCC6F}"/>
                </a:ext>
              </a:extLst>
            </p:cNvPr>
            <p:cNvSpPr txBox="1"/>
            <p:nvPr/>
          </p:nvSpPr>
          <p:spPr>
            <a:xfrm rot="18855138">
              <a:off x="2537203" y="7159646"/>
              <a:ext cx="600301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4041233-5E97-48B2-8285-4AA82DBC0451}"/>
                </a:ext>
              </a:extLst>
            </p:cNvPr>
            <p:cNvSpPr txBox="1"/>
            <p:nvPr/>
          </p:nvSpPr>
          <p:spPr>
            <a:xfrm rot="18855138">
              <a:off x="2889398" y="7159646"/>
              <a:ext cx="600301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FE4E6FB-F6A7-4AF6-992C-9C535B19C9DD}"/>
                </a:ext>
              </a:extLst>
            </p:cNvPr>
            <p:cNvSpPr txBox="1"/>
            <p:nvPr/>
          </p:nvSpPr>
          <p:spPr>
            <a:xfrm rot="18855138">
              <a:off x="3236758" y="7159646"/>
              <a:ext cx="600301" cy="295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1932BA1-728B-4B33-B131-E4065530190E}"/>
                </a:ext>
              </a:extLst>
            </p:cNvPr>
            <p:cNvSpPr txBox="1"/>
            <p:nvPr/>
          </p:nvSpPr>
          <p:spPr>
            <a:xfrm rot="18855138">
              <a:off x="3561706" y="7163985"/>
              <a:ext cx="600301" cy="286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5113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5</TotalTime>
  <Words>43</Words>
  <Application>Microsoft Office PowerPoint</Application>
  <PresentationFormat>A4 纸张(210x297 毫米)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 Xiang</dc:creator>
  <cp:lastModifiedBy>Administrator</cp:lastModifiedBy>
  <cp:revision>85</cp:revision>
  <dcterms:created xsi:type="dcterms:W3CDTF">2022-05-17T08:41:59Z</dcterms:created>
  <dcterms:modified xsi:type="dcterms:W3CDTF">2023-01-10T09:03:40Z</dcterms:modified>
</cp:coreProperties>
</file>